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13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0192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4626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7869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0602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38323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0375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5273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09226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98967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35766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1614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0992F-0230-4AE9-A539-1B1FA895572B}" type="datetimeFigureOut">
              <a:rPr kumimoji="1" lang="ja-JP" altLang="en-US" smtClean="0"/>
              <a:t>2021/12/1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B25B05-5280-4E40-B02E-2B73D0CE189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264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77046579"/>
              </p:ext>
            </p:extLst>
          </p:nvPr>
        </p:nvGraphicFramePr>
        <p:xfrm>
          <a:off x="253815" y="2216175"/>
          <a:ext cx="8742217" cy="2076393"/>
        </p:xfrm>
        <a:graphic>
          <a:graphicData uri="http://schemas.openxmlformats.org/drawingml/2006/table">
            <a:tbl>
              <a:tblPr/>
              <a:tblGrid>
                <a:gridCol w="1064578">
                  <a:extLst>
                    <a:ext uri="{9D8B030D-6E8A-4147-A177-3AD203B41FA5}">
                      <a16:colId xmlns:a16="http://schemas.microsoft.com/office/drawing/2014/main" xmlns="" val="920473920"/>
                    </a:ext>
                  </a:extLst>
                </a:gridCol>
                <a:gridCol w="547497">
                  <a:extLst>
                    <a:ext uri="{9D8B030D-6E8A-4147-A177-3AD203B41FA5}">
                      <a16:colId xmlns:a16="http://schemas.microsoft.com/office/drawing/2014/main" xmlns="" val="4014055386"/>
                    </a:ext>
                  </a:extLst>
                </a:gridCol>
                <a:gridCol w="205312">
                  <a:extLst>
                    <a:ext uri="{9D8B030D-6E8A-4147-A177-3AD203B41FA5}">
                      <a16:colId xmlns:a16="http://schemas.microsoft.com/office/drawing/2014/main" xmlns="" val="2222156707"/>
                    </a:ext>
                  </a:extLst>
                </a:gridCol>
                <a:gridCol w="319373">
                  <a:extLst>
                    <a:ext uri="{9D8B030D-6E8A-4147-A177-3AD203B41FA5}">
                      <a16:colId xmlns:a16="http://schemas.microsoft.com/office/drawing/2014/main" xmlns="" val="1285567614"/>
                    </a:ext>
                  </a:extLst>
                </a:gridCol>
                <a:gridCol w="223054">
                  <a:extLst>
                    <a:ext uri="{9D8B030D-6E8A-4147-A177-3AD203B41FA5}">
                      <a16:colId xmlns:a16="http://schemas.microsoft.com/office/drawing/2014/main" xmlns="" val="2260260778"/>
                    </a:ext>
                  </a:extLst>
                </a:gridCol>
                <a:gridCol w="547497">
                  <a:extLst>
                    <a:ext uri="{9D8B030D-6E8A-4147-A177-3AD203B41FA5}">
                      <a16:colId xmlns:a16="http://schemas.microsoft.com/office/drawing/2014/main" xmlns="" val="2180966512"/>
                    </a:ext>
                  </a:extLst>
                </a:gridCol>
                <a:gridCol w="235728">
                  <a:extLst>
                    <a:ext uri="{9D8B030D-6E8A-4147-A177-3AD203B41FA5}">
                      <a16:colId xmlns:a16="http://schemas.microsoft.com/office/drawing/2014/main" xmlns="" val="899073046"/>
                    </a:ext>
                  </a:extLst>
                </a:gridCol>
                <a:gridCol w="410623">
                  <a:extLst>
                    <a:ext uri="{9D8B030D-6E8A-4147-A177-3AD203B41FA5}">
                      <a16:colId xmlns:a16="http://schemas.microsoft.com/office/drawing/2014/main" xmlns="" val="1533546896"/>
                    </a:ext>
                  </a:extLst>
                </a:gridCol>
                <a:gridCol w="223054">
                  <a:extLst>
                    <a:ext uri="{9D8B030D-6E8A-4147-A177-3AD203B41FA5}">
                      <a16:colId xmlns:a16="http://schemas.microsoft.com/office/drawing/2014/main" xmlns="" val="3851822366"/>
                    </a:ext>
                  </a:extLst>
                </a:gridCol>
                <a:gridCol w="547497">
                  <a:extLst>
                    <a:ext uri="{9D8B030D-6E8A-4147-A177-3AD203B41FA5}">
                      <a16:colId xmlns:a16="http://schemas.microsoft.com/office/drawing/2014/main" xmlns="" val="344953634"/>
                    </a:ext>
                  </a:extLst>
                </a:gridCol>
                <a:gridCol w="235728">
                  <a:extLst>
                    <a:ext uri="{9D8B030D-6E8A-4147-A177-3AD203B41FA5}">
                      <a16:colId xmlns:a16="http://schemas.microsoft.com/office/drawing/2014/main" xmlns="" val="3596812088"/>
                    </a:ext>
                  </a:extLst>
                </a:gridCol>
                <a:gridCol w="387812">
                  <a:extLst>
                    <a:ext uri="{9D8B030D-6E8A-4147-A177-3AD203B41FA5}">
                      <a16:colId xmlns:a16="http://schemas.microsoft.com/office/drawing/2014/main" xmlns="" val="3990116484"/>
                    </a:ext>
                  </a:extLst>
                </a:gridCol>
                <a:gridCol w="223054">
                  <a:extLst>
                    <a:ext uri="{9D8B030D-6E8A-4147-A177-3AD203B41FA5}">
                      <a16:colId xmlns:a16="http://schemas.microsoft.com/office/drawing/2014/main" xmlns="" val="2389446709"/>
                    </a:ext>
                  </a:extLst>
                </a:gridCol>
                <a:gridCol w="547497">
                  <a:extLst>
                    <a:ext uri="{9D8B030D-6E8A-4147-A177-3AD203B41FA5}">
                      <a16:colId xmlns:a16="http://schemas.microsoft.com/office/drawing/2014/main" xmlns="" val="2040111791"/>
                    </a:ext>
                  </a:extLst>
                </a:gridCol>
                <a:gridCol w="235728">
                  <a:extLst>
                    <a:ext uri="{9D8B030D-6E8A-4147-A177-3AD203B41FA5}">
                      <a16:colId xmlns:a16="http://schemas.microsoft.com/office/drawing/2014/main" xmlns="" val="3321799114"/>
                    </a:ext>
                  </a:extLst>
                </a:gridCol>
                <a:gridCol w="387812">
                  <a:extLst>
                    <a:ext uri="{9D8B030D-6E8A-4147-A177-3AD203B41FA5}">
                      <a16:colId xmlns:a16="http://schemas.microsoft.com/office/drawing/2014/main" xmlns="" val="3446027273"/>
                    </a:ext>
                  </a:extLst>
                </a:gridCol>
                <a:gridCol w="223054">
                  <a:extLst>
                    <a:ext uri="{9D8B030D-6E8A-4147-A177-3AD203B41FA5}">
                      <a16:colId xmlns:a16="http://schemas.microsoft.com/office/drawing/2014/main" xmlns="" val="3493887974"/>
                    </a:ext>
                  </a:extLst>
                </a:gridCol>
                <a:gridCol w="387812">
                  <a:extLst>
                    <a:ext uri="{9D8B030D-6E8A-4147-A177-3AD203B41FA5}">
                      <a16:colId xmlns:a16="http://schemas.microsoft.com/office/drawing/2014/main" xmlns="" val="1165224913"/>
                    </a:ext>
                  </a:extLst>
                </a:gridCol>
                <a:gridCol w="235728">
                  <a:extLst>
                    <a:ext uri="{9D8B030D-6E8A-4147-A177-3AD203B41FA5}">
                      <a16:colId xmlns:a16="http://schemas.microsoft.com/office/drawing/2014/main" xmlns="" val="54456253"/>
                    </a:ext>
                  </a:extLst>
                </a:gridCol>
                <a:gridCol w="319373">
                  <a:extLst>
                    <a:ext uri="{9D8B030D-6E8A-4147-A177-3AD203B41FA5}">
                      <a16:colId xmlns:a16="http://schemas.microsoft.com/office/drawing/2014/main" xmlns="" val="2344497719"/>
                    </a:ext>
                  </a:extLst>
                </a:gridCol>
                <a:gridCol w="223054">
                  <a:extLst>
                    <a:ext uri="{9D8B030D-6E8A-4147-A177-3AD203B41FA5}">
                      <a16:colId xmlns:a16="http://schemas.microsoft.com/office/drawing/2014/main" xmlns="" val="1273522459"/>
                    </a:ext>
                  </a:extLst>
                </a:gridCol>
                <a:gridCol w="387812">
                  <a:extLst>
                    <a:ext uri="{9D8B030D-6E8A-4147-A177-3AD203B41FA5}">
                      <a16:colId xmlns:a16="http://schemas.microsoft.com/office/drawing/2014/main" xmlns="" val="1185833665"/>
                    </a:ext>
                  </a:extLst>
                </a:gridCol>
                <a:gridCol w="235728">
                  <a:extLst>
                    <a:ext uri="{9D8B030D-6E8A-4147-A177-3AD203B41FA5}">
                      <a16:colId xmlns:a16="http://schemas.microsoft.com/office/drawing/2014/main" xmlns="" val="806413951"/>
                    </a:ext>
                  </a:extLst>
                </a:gridCol>
                <a:gridCol w="387812">
                  <a:extLst>
                    <a:ext uri="{9D8B030D-6E8A-4147-A177-3AD203B41FA5}">
                      <a16:colId xmlns:a16="http://schemas.microsoft.com/office/drawing/2014/main" xmlns="" val="2376510398"/>
                    </a:ext>
                  </a:extLst>
                </a:gridCol>
              </a:tblGrid>
              <a:tr h="362431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days</a:t>
                      </a:r>
                    </a:p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(g/week)</a:t>
                      </a:r>
                      <a:endParaRPr 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4day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/week)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1day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/week)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8day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/week)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5day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/week)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days</a:t>
                      </a:r>
                    </a:p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(g/week)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2511475643"/>
                  </a:ext>
                </a:extLst>
              </a:tr>
              <a:tr h="362431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ontrol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.4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2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.4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1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.9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3.8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1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.4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6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7.8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6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43197723"/>
                  </a:ext>
                </a:extLst>
              </a:tr>
              <a:tr h="362431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%SKK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9.8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2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.8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5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1.5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3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5.6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2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.0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5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.4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4 </a:t>
                      </a:r>
                      <a:endParaRPr lang="en-US" altLang="ja-JP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468604337"/>
                  </a:ext>
                </a:extLst>
              </a:tr>
              <a:tr h="362431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%SKK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1.7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5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4.8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5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.5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9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0.1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3.6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5.4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2.9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6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9.6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2 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04449931"/>
                  </a:ext>
                </a:extLst>
              </a:tr>
              <a:tr h="362431">
                <a:tc>
                  <a:txBody>
                    <a:bodyPr/>
                    <a:lstStyle/>
                    <a:p>
                      <a:pPr algn="l" fontAlgn="b"/>
                      <a:r>
                        <a:rPr lang="en-US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Resveratrol 0.4%</a:t>
                      </a:r>
                    </a:p>
                  </a:txBody>
                  <a:tcPr marL="6870" marR="6870" marT="687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2.3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8.2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3.2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.0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3.8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9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4.4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7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3.9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.5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57.9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±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.4 </a:t>
                      </a:r>
                    </a:p>
                  </a:txBody>
                  <a:tcPr marL="6870" marR="6870" marT="687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20317186"/>
                  </a:ext>
                </a:extLst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146304" y="1846843"/>
            <a:ext cx="6370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information 3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od intake for 42 days in </a:t>
            </a:r>
            <a:r>
              <a:rPr kumimoji="1" lang="en-US" altLang="ja-JP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KAy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ice.</a:t>
            </a:r>
            <a:endParaRPr kumimoji="1" lang="ja-JP" altLang="en-US" dirty="0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56616" y="4477234"/>
            <a:ext cx="45720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s are expressed as means ± S.D. (n = 7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1349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128</Words>
  <Application>Microsoft Office PowerPoint</Application>
  <PresentationFormat>On-screen Show (4:3)</PresentationFormat>
  <Paragraphs>10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常風 興平</dc:creator>
  <cp:lastModifiedBy>Kalyana Sundaram T.V</cp:lastModifiedBy>
  <cp:revision>9</cp:revision>
  <dcterms:created xsi:type="dcterms:W3CDTF">2021-06-29T06:41:36Z</dcterms:created>
  <dcterms:modified xsi:type="dcterms:W3CDTF">2021-12-17T01:29:38Z</dcterms:modified>
</cp:coreProperties>
</file>